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0" autoAdjust="0"/>
    <p:restoredTop sz="94660"/>
  </p:normalViewPr>
  <p:slideViewPr>
    <p:cSldViewPr snapToGrid="0">
      <p:cViewPr varScale="1">
        <p:scale>
          <a:sx n="62" d="100"/>
          <a:sy n="62" d="100"/>
        </p:scale>
        <p:origin x="828" y="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誠一郎 藤嶋" userId="786ed1629b124a31" providerId="LiveId" clId="{4CADA859-D84C-44A1-9ADA-79A443BD6227}"/>
    <pc:docChg chg="modSld">
      <pc:chgData name="誠一郎 藤嶋" userId="786ed1629b124a31" providerId="LiveId" clId="{4CADA859-D84C-44A1-9ADA-79A443BD6227}" dt="2025-06-13T13:52:17.994" v="1" actId="1076"/>
      <pc:docMkLst>
        <pc:docMk/>
      </pc:docMkLst>
      <pc:sldChg chg="modSp mod">
        <pc:chgData name="誠一郎 藤嶋" userId="786ed1629b124a31" providerId="LiveId" clId="{4CADA859-D84C-44A1-9ADA-79A443BD6227}" dt="2025-06-13T13:52:17.994" v="1" actId="1076"/>
        <pc:sldMkLst>
          <pc:docMk/>
          <pc:sldMk cId="3207113694" sldId="258"/>
        </pc:sldMkLst>
        <pc:spChg chg="mod">
          <ac:chgData name="誠一郎 藤嶋" userId="786ed1629b124a31" providerId="LiveId" clId="{4CADA859-D84C-44A1-9ADA-79A443BD6227}" dt="2025-06-13T13:52:17.994" v="1" actId="1076"/>
          <ac:spMkLst>
            <pc:docMk/>
            <pc:sldMk cId="3207113694" sldId="258"/>
            <ac:spMk id="11" creationId="{288B099F-58B7-16E0-F0EF-11952F76C249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D67DBA-67E7-45FF-89CA-5185C9F3BF1C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F9E4D1-E24A-4F72-BE08-B8B01A9E6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5079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2421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4DF0C-1DFF-D88B-94F8-3A488E29D9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9B7AE8-88A2-EFC6-8982-D7CE842CC8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0EB80F-C4DE-EEF6-D38C-1E00FC768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74322C-FF4F-119E-EDF1-7C1EF4744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80EFED-FD52-5885-6D65-AC0CB8D87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554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80778F-8096-C23B-C977-9094EA2FE9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6D3977-4BDB-15A3-9BCC-F4D5C9F4DA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FB35CA-429A-7B88-861D-A9ADDB856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3F401-DC21-09DE-A665-DAE563FF5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022137-C3E5-A5F9-3E40-10D258E7B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040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3B6D64-AB17-79B4-3EC2-5A68B83637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C78655-0F85-706B-A816-DBD98DD97A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4571E1-7593-14BB-61F5-2120CF642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C6C4F8-8065-69F8-559F-306898EFD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B9ADF2-5F4D-71EB-7E6B-A52B7A293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053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6F0919-6221-2C06-1C61-79E31692BD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6450BA-2B9D-B389-1E38-BC90F72AC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A005F9-2207-53C6-6A8B-522F1D8E1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5EECE0-2382-5C80-0A95-EED8B5310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967A58-C140-10AA-EA48-B9F4FC681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68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86A037-0C51-286C-189A-C0D2320E2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9C11F6-4093-8DC6-D664-A2881F9EB2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C4E4A2-DA95-379F-1937-48CF59163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39CC87-FE53-9A7A-D8E4-DE0D9519F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448AFD-4037-05BE-D4C6-31B4622CE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439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964058-5AEE-4E87-938E-BD2F49A6C1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13F724-BDD6-0F4A-2F13-4DB1221B69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98F874-0964-44D2-4CC3-BE2630EEA6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DD3976-48D2-F17B-BDDD-2B3E7F5BCE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FED585-2E76-5E65-A838-7CC523D69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EA6BA8-11B2-FA7A-5A4B-87689BF07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021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0ACE8-ECEC-6B03-C0D8-5E4715E144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2DC95A-57C2-ABEE-F9CB-8BB94E2D6C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294E56-C3BC-0608-8DCC-4434820A4F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18FA26-2A81-66E9-54B2-2E87189803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3304DD-7F9D-8C50-ACF4-987E5B2E84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D3C32A4-718D-CFC3-2711-F679F68D4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DC21B1-DB33-3570-B7FB-06602D475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026E84-41C9-6804-BD09-FF5A81F3D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354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D7338F-631F-21D6-994C-D9A2394C82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F1E734C-714E-CF65-509C-FBF733C44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5F96D5-839E-4BD3-BFA6-71A2052B7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949EB64-7FD4-A4EA-CC31-B663EA853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166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CD4BF1-C3EC-7982-5078-B38CBF2A4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F207C21-E62E-19F3-5DBD-38CCB4070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65199D-79CB-0417-343C-67A6958204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404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E02505-DFC2-A64E-39B5-8FEC63AE83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8707FB-81BF-2696-2200-1D9663A1E9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0FC337-8F57-B2E0-D0A9-37160D7D79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6F4C9F-6F86-EA3C-FFA7-7296EDCF6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4AF8FC-08FC-2F56-31B4-F6F92CBF8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608CC8-8331-8E79-3057-3AC8030EF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140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AC1659-FC6E-5950-2767-B2CFBA8233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CC810B-D100-169C-FBC4-C3D31C1A39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45F0A6-D6CD-A691-FF96-F4BCA1FF07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525E70-40DF-00C4-562C-D3146FC31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EF9936-CD36-C39C-4541-014B33178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C8B070-ED93-2710-68AB-84C723D79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9395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4A8418-8E07-5D05-4DB4-85D8376922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1CE864-5702-552B-0507-FBEDC657BF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92D78F-E1F2-E6B0-2CF1-A319CD7622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14271-DB89-48E5-B63A-C52193956D34}" type="datetimeFigureOut">
              <a:rPr lang="en-US" smtClean="0"/>
              <a:t>6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8FE589-50FC-8335-4785-7F9697D5F1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F957C6-4C15-ECC5-BA51-BCEF281FC1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742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8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1208743-1FFA-B6EF-D026-0879641480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982" y="39507"/>
            <a:ext cx="1157020" cy="1530488"/>
          </a:xfrm>
          <a:prstGeom prst="rect">
            <a:avLst/>
          </a:prstGeom>
        </p:spPr>
      </p:pic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55699966-DA4C-7A19-EC2D-9B0112BAA90A}"/>
              </a:ext>
            </a:extLst>
          </p:cNvPr>
          <p:cNvSpPr/>
          <p:nvPr/>
        </p:nvSpPr>
        <p:spPr>
          <a:xfrm>
            <a:off x="61917" y="1593160"/>
            <a:ext cx="6768350" cy="479005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15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C714206-E71C-1D37-11B9-443FC28EA08E}"/>
              </a:ext>
            </a:extLst>
          </p:cNvPr>
          <p:cNvSpPr txBox="1"/>
          <p:nvPr/>
        </p:nvSpPr>
        <p:spPr>
          <a:xfrm>
            <a:off x="6721157" y="403532"/>
            <a:ext cx="5815628" cy="53348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67" u="sng" dirty="0">
                <a:solidFill>
                  <a:srgbClr val="FFFF00"/>
                </a:solidFill>
              </a:rPr>
              <a:t>Key Findings</a:t>
            </a:r>
          </a:p>
          <a:p>
            <a:pPr marL="341300" indent="-341300">
              <a:buFont typeface="Wingdings" panose="05000000000000000000" pitchFamily="2" charset="2"/>
              <a:buChar char="Ø"/>
            </a:pPr>
            <a:r>
              <a:rPr lang="en-US" sz="2400" dirty="0">
                <a:solidFill>
                  <a:schemeClr val="bg1"/>
                </a:solidFill>
              </a:rPr>
              <a:t>Prompt diagnosis of SBO is crucial for achieving optimal treatment outcomes.</a:t>
            </a:r>
          </a:p>
          <a:p>
            <a:endParaRPr lang="en-US" sz="2400" dirty="0">
              <a:solidFill>
                <a:schemeClr val="bg1"/>
              </a:solidFill>
            </a:endParaRPr>
          </a:p>
          <a:p>
            <a:pPr marL="341300" indent="-341300">
              <a:buFont typeface="Wingdings" panose="05000000000000000000" pitchFamily="2" charset="2"/>
              <a:buChar char="Ø"/>
            </a:pPr>
            <a:r>
              <a:rPr lang="en-US" sz="2400" dirty="0">
                <a:solidFill>
                  <a:schemeClr val="bg1"/>
                </a:solidFill>
              </a:rPr>
              <a:t>This study determined whether the intestinal-to-liver CT attenuation value ratio can predict intestinal ischemia in patients who underwent emergency laparotomy for SBO.</a:t>
            </a:r>
          </a:p>
          <a:p>
            <a:pPr marL="341300" indent="-341300">
              <a:buFont typeface="Wingdings" panose="05000000000000000000" pitchFamily="2" charset="2"/>
              <a:buChar char="Ø"/>
            </a:pPr>
            <a:endParaRPr lang="en-US" sz="2400" dirty="0">
              <a:solidFill>
                <a:schemeClr val="bg1"/>
              </a:solidFill>
            </a:endParaRPr>
          </a:p>
          <a:p>
            <a:pPr marL="341300" indent="-341300">
              <a:buFont typeface="Wingdings" panose="05000000000000000000" pitchFamily="2" charset="2"/>
              <a:buChar char="Ø"/>
            </a:pPr>
            <a:r>
              <a:rPr lang="en-US" sz="2400" dirty="0">
                <a:solidFill>
                  <a:schemeClr val="bg1"/>
                </a:solidFill>
              </a:rPr>
              <a:t>Intestinal-to-liver CT attenuation value ratio below 0.40 is a strong predictor of intestinal ischemia requiring resection in SBO patients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F50FFCA-6844-FB2B-BAE7-1CD7EB062C65}"/>
              </a:ext>
            </a:extLst>
          </p:cNvPr>
          <p:cNvSpPr txBox="1"/>
          <p:nvPr/>
        </p:nvSpPr>
        <p:spPr>
          <a:xfrm>
            <a:off x="17910" y="6412771"/>
            <a:ext cx="7632627" cy="42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50" dirty="0">
                <a:solidFill>
                  <a:schemeClr val="bg1"/>
                </a:solidFill>
              </a:rPr>
              <a:t>Fujishima, F., Tsujimoto, H., Yaguchi, Y., et al. </a:t>
            </a:r>
            <a:r>
              <a:rPr lang="en-US" sz="2150" i="1" dirty="0">
                <a:solidFill>
                  <a:schemeClr val="bg1"/>
                </a:solidFill>
              </a:rPr>
              <a:t>Emergency Radiology</a:t>
            </a:r>
            <a:endParaRPr lang="en-US" sz="2150" dirty="0">
              <a:solidFill>
                <a:schemeClr val="bg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88B099F-58B7-16E0-F0EF-11952F76C249}"/>
              </a:ext>
            </a:extLst>
          </p:cNvPr>
          <p:cNvSpPr txBox="1"/>
          <p:nvPr/>
        </p:nvSpPr>
        <p:spPr>
          <a:xfrm>
            <a:off x="1468934" y="221464"/>
            <a:ext cx="475746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chemeClr val="bg1"/>
                </a:solidFill>
              </a:rPr>
              <a:t>Preoperative intestine-to-liver CT ratio: Useful predictor of resection in strangulated obstruction</a:t>
            </a:r>
          </a:p>
        </p:txBody>
      </p: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8E6F37E2-3AC1-CA3C-6AB1-55D35ECFFE00}"/>
              </a:ext>
            </a:extLst>
          </p:cNvPr>
          <p:cNvGrpSpPr/>
          <p:nvPr/>
        </p:nvGrpSpPr>
        <p:grpSpPr>
          <a:xfrm>
            <a:off x="215140" y="1793554"/>
            <a:ext cx="3108515" cy="2442879"/>
            <a:chOff x="1239992" y="4892474"/>
            <a:chExt cx="4320836" cy="3713167"/>
          </a:xfrm>
        </p:grpSpPr>
        <p:pic>
          <p:nvPicPr>
            <p:cNvPr id="45" name="図 44">
              <a:extLst>
                <a:ext uri="{FF2B5EF4-FFF2-40B4-BE49-F238E27FC236}">
                  <a16:creationId xmlns:a16="http://schemas.microsoft.com/office/drawing/2014/main" id="{EF851DF8-95B9-25E9-20A9-E70A4D70D8E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82" t="4505" r="6980"/>
            <a:stretch/>
          </p:blipFill>
          <p:spPr>
            <a:xfrm>
              <a:off x="1297171" y="4954988"/>
              <a:ext cx="4263657" cy="3650653"/>
            </a:xfrm>
            <a:prstGeom prst="rect">
              <a:avLst/>
            </a:prstGeom>
          </p:spPr>
        </p:pic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2668B9A4-18C4-269C-71BE-F1B9353CCCCC}"/>
                </a:ext>
              </a:extLst>
            </p:cNvPr>
            <p:cNvSpPr txBox="1"/>
            <p:nvPr/>
          </p:nvSpPr>
          <p:spPr>
            <a:xfrm>
              <a:off x="1254866" y="4892474"/>
              <a:ext cx="417844" cy="502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フローチャート: 結合子 46">
              <a:extLst>
                <a:ext uri="{FF2B5EF4-FFF2-40B4-BE49-F238E27FC236}">
                  <a16:creationId xmlns:a16="http://schemas.microsoft.com/office/drawing/2014/main" id="{C5320F86-6067-CE50-BFFB-6416BE47F1B8}"/>
                </a:ext>
              </a:extLst>
            </p:cNvPr>
            <p:cNvSpPr/>
            <p:nvPr/>
          </p:nvSpPr>
          <p:spPr>
            <a:xfrm>
              <a:off x="2153386" y="5948559"/>
              <a:ext cx="32385" cy="43200"/>
            </a:xfrm>
            <a:prstGeom prst="flowChartConnector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フローチャート: 結合子 47">
              <a:extLst>
                <a:ext uri="{FF2B5EF4-FFF2-40B4-BE49-F238E27FC236}">
                  <a16:creationId xmlns:a16="http://schemas.microsoft.com/office/drawing/2014/main" id="{C241CDA4-34A2-7B7B-E168-2FE38E20DF94}"/>
                </a:ext>
              </a:extLst>
            </p:cNvPr>
            <p:cNvSpPr/>
            <p:nvPr/>
          </p:nvSpPr>
          <p:spPr>
            <a:xfrm>
              <a:off x="1993898" y="6398670"/>
              <a:ext cx="32385" cy="43200"/>
            </a:xfrm>
            <a:prstGeom prst="flowChartConnector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フローチャート: 結合子 48">
              <a:extLst>
                <a:ext uri="{FF2B5EF4-FFF2-40B4-BE49-F238E27FC236}">
                  <a16:creationId xmlns:a16="http://schemas.microsoft.com/office/drawing/2014/main" id="{FD5CBE66-FAFF-6287-14B2-073222A832E6}"/>
                </a:ext>
              </a:extLst>
            </p:cNvPr>
            <p:cNvSpPr/>
            <p:nvPr/>
          </p:nvSpPr>
          <p:spPr>
            <a:xfrm>
              <a:off x="2185771" y="7157570"/>
              <a:ext cx="32385" cy="43200"/>
            </a:xfrm>
            <a:prstGeom prst="flowChartConnector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121CE5F8-6CAB-B6E9-7F20-B6E40ECFD84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091131" y="5255286"/>
              <a:ext cx="62255" cy="597584"/>
            </a:xfrm>
            <a:prstGeom prst="line">
              <a:avLst/>
            </a:prstGeom>
            <a:ln w="19050">
              <a:solidFill>
                <a:srgbClr val="FFFF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B37F3B8A-B262-2788-A955-3AD38C099DFE}"/>
                </a:ext>
              </a:extLst>
            </p:cNvPr>
            <p:cNvCxnSpPr>
              <a:cxnSpLocks/>
              <a:endCxn id="54" idx="2"/>
            </p:cNvCxnSpPr>
            <p:nvPr/>
          </p:nvCxnSpPr>
          <p:spPr>
            <a:xfrm flipH="1" flipV="1">
              <a:off x="1712945" y="6232985"/>
              <a:ext cx="182241" cy="23553"/>
            </a:xfrm>
            <a:prstGeom prst="line">
              <a:avLst/>
            </a:prstGeom>
            <a:ln w="19050">
              <a:solidFill>
                <a:srgbClr val="FFFF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4C39E619-9AA0-DFDF-A692-2ACEBC4083E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50039" y="7260679"/>
              <a:ext cx="447380" cy="530195"/>
            </a:xfrm>
            <a:prstGeom prst="line">
              <a:avLst/>
            </a:prstGeom>
            <a:ln w="19050">
              <a:solidFill>
                <a:srgbClr val="FFFF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AEEEDA9A-9C18-4DC7-9094-1D181E4211FF}"/>
                </a:ext>
              </a:extLst>
            </p:cNvPr>
            <p:cNvSpPr txBox="1"/>
            <p:nvPr/>
          </p:nvSpPr>
          <p:spPr>
            <a:xfrm>
              <a:off x="1673288" y="4963391"/>
              <a:ext cx="1075716" cy="43893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4 HU</a:t>
              </a: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A798D8C7-5A33-2863-7423-A415E77018F9}"/>
                </a:ext>
              </a:extLst>
            </p:cNvPr>
            <p:cNvSpPr txBox="1"/>
            <p:nvPr/>
          </p:nvSpPr>
          <p:spPr>
            <a:xfrm>
              <a:off x="1239992" y="5794055"/>
              <a:ext cx="945905" cy="43893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7 HU</a:t>
              </a: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3343992E-39C6-BFEB-1933-61B856877877}"/>
                </a:ext>
              </a:extLst>
            </p:cNvPr>
            <p:cNvSpPr txBox="1"/>
            <p:nvPr/>
          </p:nvSpPr>
          <p:spPr>
            <a:xfrm>
              <a:off x="1276609" y="7790874"/>
              <a:ext cx="1075716" cy="43893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3 HU</a:t>
              </a:r>
            </a:p>
          </p:txBody>
        </p:sp>
      </p:grp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5107D4D9-A16A-5C8C-3F00-73A164302D7B}"/>
              </a:ext>
            </a:extLst>
          </p:cNvPr>
          <p:cNvGrpSpPr/>
          <p:nvPr/>
        </p:nvGrpSpPr>
        <p:grpSpPr>
          <a:xfrm>
            <a:off x="3376859" y="1820016"/>
            <a:ext cx="3282524" cy="2427019"/>
            <a:chOff x="1211191" y="4732926"/>
            <a:chExt cx="4464966" cy="3269825"/>
          </a:xfrm>
        </p:grpSpPr>
        <p:pic>
          <p:nvPicPr>
            <p:cNvPr id="57" name="図 56">
              <a:extLst>
                <a:ext uri="{FF2B5EF4-FFF2-40B4-BE49-F238E27FC236}">
                  <a16:creationId xmlns:a16="http://schemas.microsoft.com/office/drawing/2014/main" id="{1A2C3A58-04F6-4194-C305-64FC9C9F74B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19" t="6005" r="6583"/>
            <a:stretch/>
          </p:blipFill>
          <p:spPr>
            <a:xfrm>
              <a:off x="1211191" y="4755276"/>
              <a:ext cx="4374446" cy="3247475"/>
            </a:xfrm>
            <a:prstGeom prst="rect">
              <a:avLst/>
            </a:prstGeom>
          </p:spPr>
        </p:pic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BFB16047-56DB-3D41-AE90-81212FCFDFB6}"/>
                </a:ext>
              </a:extLst>
            </p:cNvPr>
            <p:cNvSpPr txBox="1"/>
            <p:nvPr/>
          </p:nvSpPr>
          <p:spPr>
            <a:xfrm>
              <a:off x="1211191" y="4732926"/>
              <a:ext cx="417843" cy="456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フローチャート: 結合子 58">
              <a:extLst>
                <a:ext uri="{FF2B5EF4-FFF2-40B4-BE49-F238E27FC236}">
                  <a16:creationId xmlns:a16="http://schemas.microsoft.com/office/drawing/2014/main" id="{00F1AE2F-ADC7-FA3C-269E-A1CF532BCAA5}"/>
                </a:ext>
              </a:extLst>
            </p:cNvPr>
            <p:cNvSpPr/>
            <p:nvPr/>
          </p:nvSpPr>
          <p:spPr>
            <a:xfrm>
              <a:off x="3969229" y="6566705"/>
              <a:ext cx="32385" cy="43200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フローチャート: 結合子 59">
              <a:extLst>
                <a:ext uri="{FF2B5EF4-FFF2-40B4-BE49-F238E27FC236}">
                  <a16:creationId xmlns:a16="http://schemas.microsoft.com/office/drawing/2014/main" id="{322C3D38-C37B-04C7-C035-29EB3F52CF63}"/>
                </a:ext>
              </a:extLst>
            </p:cNvPr>
            <p:cNvSpPr/>
            <p:nvPr/>
          </p:nvSpPr>
          <p:spPr>
            <a:xfrm>
              <a:off x="4688700" y="6697839"/>
              <a:ext cx="32385" cy="43200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フローチャート: 結合子 60">
              <a:extLst>
                <a:ext uri="{FF2B5EF4-FFF2-40B4-BE49-F238E27FC236}">
                  <a16:creationId xmlns:a16="http://schemas.microsoft.com/office/drawing/2014/main" id="{2DFD1EAD-23B5-ABF8-B7CA-97D76DEA4510}"/>
                </a:ext>
              </a:extLst>
            </p:cNvPr>
            <p:cNvSpPr/>
            <p:nvPr/>
          </p:nvSpPr>
          <p:spPr>
            <a:xfrm>
              <a:off x="4142895" y="6088985"/>
              <a:ext cx="32385" cy="43200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724F2955-75C7-E9C7-0F99-093755E9077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89264" y="5638388"/>
              <a:ext cx="546117" cy="1009983"/>
            </a:xfrm>
            <a:prstGeom prst="line">
              <a:avLst/>
            </a:prstGeom>
            <a:ln w="19050">
              <a:solidFill>
                <a:srgbClr val="FF00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50675F3C-2050-41CF-B25A-E428A03A2CD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18333" y="5066715"/>
              <a:ext cx="868870" cy="955723"/>
            </a:xfrm>
            <a:prstGeom prst="line">
              <a:avLst/>
            </a:prstGeom>
            <a:ln w="19050">
              <a:solidFill>
                <a:srgbClr val="FF00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>
              <a:extLst>
                <a:ext uri="{FF2B5EF4-FFF2-40B4-BE49-F238E27FC236}">
                  <a16:creationId xmlns:a16="http://schemas.microsoft.com/office/drawing/2014/main" id="{9B905507-D30E-2568-A8B7-174797A7F82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046856" y="6648371"/>
              <a:ext cx="1003202" cy="907347"/>
            </a:xfrm>
            <a:prstGeom prst="line">
              <a:avLst/>
            </a:prstGeom>
            <a:ln w="19050">
              <a:solidFill>
                <a:srgbClr val="FF00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3EB8E25C-4835-930B-F2C1-5E7B6E824652}"/>
                </a:ext>
              </a:extLst>
            </p:cNvPr>
            <p:cNvSpPr txBox="1"/>
            <p:nvPr/>
          </p:nvSpPr>
          <p:spPr>
            <a:xfrm>
              <a:off x="4793839" y="4762634"/>
              <a:ext cx="842087" cy="37319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1 HU</a:t>
              </a: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0A639BA4-A964-83C9-1F69-94B061EB45FB}"/>
                </a:ext>
              </a:extLst>
            </p:cNvPr>
            <p:cNvSpPr txBox="1"/>
            <p:nvPr/>
          </p:nvSpPr>
          <p:spPr>
            <a:xfrm>
              <a:off x="4834070" y="5327951"/>
              <a:ext cx="842087" cy="37319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 HU</a:t>
              </a: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96E28716-F834-AB14-FFA9-788308B19DD3}"/>
                </a:ext>
              </a:extLst>
            </p:cNvPr>
            <p:cNvSpPr txBox="1"/>
            <p:nvPr/>
          </p:nvSpPr>
          <p:spPr>
            <a:xfrm>
              <a:off x="4764509" y="7555718"/>
              <a:ext cx="842087" cy="37319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2 HU</a:t>
              </a:r>
            </a:p>
          </p:txBody>
        </p:sp>
      </p:grp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FFF53E4A-BC28-C872-F6C2-0283427A3DD2}"/>
              </a:ext>
            </a:extLst>
          </p:cNvPr>
          <p:cNvGrpSpPr/>
          <p:nvPr/>
        </p:nvGrpSpPr>
        <p:grpSpPr>
          <a:xfrm>
            <a:off x="268726" y="4238003"/>
            <a:ext cx="3081531" cy="2152960"/>
            <a:chOff x="1134140" y="4972552"/>
            <a:chExt cx="4453641" cy="3317655"/>
          </a:xfrm>
        </p:grpSpPr>
        <p:pic>
          <p:nvPicPr>
            <p:cNvPr id="69" name="図 68">
              <a:extLst>
                <a:ext uri="{FF2B5EF4-FFF2-40B4-BE49-F238E27FC236}">
                  <a16:creationId xmlns:a16="http://schemas.microsoft.com/office/drawing/2014/main" id="{B1CD21B0-FEF1-2201-493D-54F50777711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967" t="5007" r="16744"/>
            <a:stretch/>
          </p:blipFill>
          <p:spPr>
            <a:xfrm>
              <a:off x="1134140" y="5008248"/>
              <a:ext cx="4408967" cy="3281959"/>
            </a:xfrm>
            <a:prstGeom prst="rect">
              <a:avLst/>
            </a:prstGeom>
          </p:spPr>
        </p:pic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0B1BB209-CF21-9A43-5128-502754F5623C}"/>
                </a:ext>
              </a:extLst>
            </p:cNvPr>
            <p:cNvSpPr txBox="1"/>
            <p:nvPr/>
          </p:nvSpPr>
          <p:spPr>
            <a:xfrm>
              <a:off x="1134140" y="4972552"/>
              <a:ext cx="417843" cy="5538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807061F7-7F9D-9566-8320-849CAFA23E3D}"/>
                </a:ext>
              </a:extLst>
            </p:cNvPr>
            <p:cNvCxnSpPr>
              <a:cxnSpLocks/>
            </p:cNvCxnSpPr>
            <p:nvPr/>
          </p:nvCxnSpPr>
          <p:spPr>
            <a:xfrm>
              <a:off x="2114972" y="5411663"/>
              <a:ext cx="491462" cy="655702"/>
            </a:xfrm>
            <a:prstGeom prst="line">
              <a:avLst/>
            </a:prstGeom>
            <a:ln w="19050">
              <a:solidFill>
                <a:srgbClr val="00B0F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フローチャート: 結合子 71">
              <a:extLst>
                <a:ext uri="{FF2B5EF4-FFF2-40B4-BE49-F238E27FC236}">
                  <a16:creationId xmlns:a16="http://schemas.microsoft.com/office/drawing/2014/main" id="{4E4E8AB6-AD41-335E-B2B4-B3FF82F83D9E}"/>
                </a:ext>
              </a:extLst>
            </p:cNvPr>
            <p:cNvSpPr/>
            <p:nvPr/>
          </p:nvSpPr>
          <p:spPr>
            <a:xfrm>
              <a:off x="2632150" y="6103939"/>
              <a:ext cx="32385" cy="43200"/>
            </a:xfrm>
            <a:prstGeom prst="flowChartConnector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フローチャート: 結合子 72">
              <a:extLst>
                <a:ext uri="{FF2B5EF4-FFF2-40B4-BE49-F238E27FC236}">
                  <a16:creationId xmlns:a16="http://schemas.microsoft.com/office/drawing/2014/main" id="{1555D915-8D70-A17B-3F2D-2798A594679F}"/>
                </a:ext>
              </a:extLst>
            </p:cNvPr>
            <p:cNvSpPr/>
            <p:nvPr/>
          </p:nvSpPr>
          <p:spPr>
            <a:xfrm>
              <a:off x="3889678" y="6355576"/>
              <a:ext cx="32385" cy="43200"/>
            </a:xfrm>
            <a:prstGeom prst="flowChartConnector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フローチャート: 結合子 73">
              <a:extLst>
                <a:ext uri="{FF2B5EF4-FFF2-40B4-BE49-F238E27FC236}">
                  <a16:creationId xmlns:a16="http://schemas.microsoft.com/office/drawing/2014/main" id="{2D77BF81-2BF4-7A82-5DB1-DF099AC788E1}"/>
                </a:ext>
              </a:extLst>
            </p:cNvPr>
            <p:cNvSpPr/>
            <p:nvPr/>
          </p:nvSpPr>
          <p:spPr>
            <a:xfrm>
              <a:off x="3302939" y="6125539"/>
              <a:ext cx="32385" cy="43200"/>
            </a:xfrm>
            <a:prstGeom prst="flowChartConnector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E30B4642-C5F1-B8E5-D697-E3AB1F9CF5C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60025" y="5291113"/>
              <a:ext cx="981518" cy="811623"/>
            </a:xfrm>
            <a:prstGeom prst="line">
              <a:avLst/>
            </a:prstGeom>
            <a:ln w="19050">
              <a:solidFill>
                <a:srgbClr val="00B0F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032691FF-98D1-0D36-D32A-EB9F48232A8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31054" y="5543953"/>
              <a:ext cx="1018471" cy="761397"/>
            </a:xfrm>
            <a:prstGeom prst="line">
              <a:avLst/>
            </a:prstGeom>
            <a:ln w="19050">
              <a:solidFill>
                <a:srgbClr val="00B0F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9490FCD3-B929-64EA-9274-BDF8216A59FF}"/>
                </a:ext>
              </a:extLst>
            </p:cNvPr>
            <p:cNvSpPr txBox="1"/>
            <p:nvPr/>
          </p:nvSpPr>
          <p:spPr>
            <a:xfrm>
              <a:off x="1728781" y="5103885"/>
              <a:ext cx="861732" cy="41538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 HU</a:t>
              </a: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A8C8A76D-DFBB-B99F-1C78-5111BE7D04E1}"/>
                </a:ext>
              </a:extLst>
            </p:cNvPr>
            <p:cNvSpPr txBox="1"/>
            <p:nvPr/>
          </p:nvSpPr>
          <p:spPr>
            <a:xfrm>
              <a:off x="4052825" y="5008250"/>
              <a:ext cx="861732" cy="41538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 HU</a:t>
              </a: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6FF75C4F-D159-F85F-D97F-116B79E5A804}"/>
                </a:ext>
              </a:extLst>
            </p:cNvPr>
            <p:cNvSpPr txBox="1"/>
            <p:nvPr/>
          </p:nvSpPr>
          <p:spPr>
            <a:xfrm>
              <a:off x="4726049" y="5250753"/>
              <a:ext cx="861732" cy="41538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3 HU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07113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F08F286B1DDA649BA39B2DAC1798716" ma:contentTypeVersion="8" ma:contentTypeDescription="Create a new document." ma:contentTypeScope="" ma:versionID="3cd5507c794a58b2c509e95efce39121">
  <xsd:schema xmlns:xsd="http://www.w3.org/2001/XMLSchema" xmlns:xs="http://www.w3.org/2001/XMLSchema" xmlns:p="http://schemas.microsoft.com/office/2006/metadata/properties" xmlns:ns3="034634f8-c37e-4ced-a8f8-2a7bf1fe9a4f" targetNamespace="http://schemas.microsoft.com/office/2006/metadata/properties" ma:root="true" ma:fieldsID="58651301d949d7359bcfb615c3a1fead" ns3:_="">
    <xsd:import namespace="034634f8-c37e-4ced-a8f8-2a7bf1fe9a4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MediaServiceObjectDetectorVersion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4634f8-c37e-4ced-a8f8-2a7bf1fe9a4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1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F0910B1-4BBD-4F23-8293-70E49B15702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34634f8-c37e-4ced-a8f8-2a7bf1fe9a4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A7D5A3F-6DB1-4611-A45A-A66B7553E90A}">
  <ds:schemaRefs>
    <ds:schemaRef ds:uri="http://purl.org/dc/elements/1.1/"/>
    <ds:schemaRef ds:uri="http://schemas.microsoft.com/office/2006/documentManagement/types"/>
    <ds:schemaRef ds:uri="http://purl.org/dc/terms/"/>
    <ds:schemaRef ds:uri="http://schemas.microsoft.com/office/2006/metadata/properties"/>
    <ds:schemaRef ds:uri="http://www.w3.org/XML/1998/namespace"/>
    <ds:schemaRef ds:uri="http://schemas.microsoft.com/office/infopath/2007/PartnerControls"/>
    <ds:schemaRef ds:uri="http://schemas.openxmlformats.org/package/2006/metadata/core-properties"/>
    <ds:schemaRef ds:uri="034634f8-c37e-4ced-a8f8-2a7bf1fe9a4f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7CFBB1AD-D770-4E10-9CF7-4BF10AA12F6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108</Words>
  <Application>Microsoft Office PowerPoint</Application>
  <PresentationFormat>ワイド画面</PresentationFormat>
  <Paragraphs>2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プレゼンテーション</vt:lpstr>
    </vt:vector>
  </TitlesOfParts>
  <Company>SpringerNatu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na Socha</dc:creator>
  <cp:lastModifiedBy>誠一郎 藤嶋</cp:lastModifiedBy>
  <cp:revision>2</cp:revision>
  <dcterms:created xsi:type="dcterms:W3CDTF">2024-04-26T15:07:57Z</dcterms:created>
  <dcterms:modified xsi:type="dcterms:W3CDTF">2025-06-13T13:52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F08F286B1DDA649BA39B2DAC1798716</vt:lpwstr>
  </property>
</Properties>
</file>